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2201F-F5AB-407F-83E1-5C7CC48837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FDD07-5239-494B-A13C-C853AE4F35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A6FA8-1DCF-489F-829E-A2E6414425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29D18-4134-4A60-BC2C-CF3293E333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ED5C2-5920-41CD-83BC-2ABE6FD719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AF7DC-160A-454B-84EA-0553BCB4F8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6DEF2-6256-4E38-8DCD-EA52AA71BF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FE8DA-653A-4016-8685-18250BD381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E974C-E782-4428-AADE-2C427E8E1B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E06B3-1C4A-43C3-913B-DEB30E764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D8CA6-6670-4C31-8B5E-BCFB6D43FB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D5823-A908-4D9F-BEFB-92BFD8457C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8D7D71-A94D-49F6-828F-C0C8C8F852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371600" y="762120"/>
            <a:ext cx="5715000" cy="27795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371600" y="3657600"/>
            <a:ext cx="5715000" cy="27892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7840080" y="61945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06000" y="1828800"/>
            <a:ext cx="96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ninf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1960" y="48006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39720" y="457200"/>
            <a:ext cx="103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 Transf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334840" y="4572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ransf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56320" y="139680"/>
            <a:ext cx="4197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ACs analysis of transferred cells from figur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4T20:13:49Z</dcterms:created>
  <dc:creator>Ana Rodriguez</dc:creator>
  <dc:description/>
  <dc:language>en-US</dc:language>
  <cp:lastModifiedBy>Ana Rodriguez</cp:lastModifiedBy>
  <dcterms:modified xsi:type="dcterms:W3CDTF">2008-03-14T20:14:29Z</dcterms:modified>
  <cp:revision>1</cp:revision>
  <dc:subject/>
  <dc:title>PowerPoint Presentation</dc:title>
</cp:coreProperties>
</file>